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5" autoAdjust="0"/>
    <p:restoredTop sz="94660"/>
  </p:normalViewPr>
  <p:slideViewPr>
    <p:cSldViewPr snapToGrid="0" showGuides="1">
      <p:cViewPr varScale="1">
        <p:scale>
          <a:sx n="91" d="100"/>
          <a:sy n="91" d="100"/>
        </p:scale>
        <p:origin x="52" y="4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64AC8C-B8CF-7EAB-F7D8-6F6C2F43FF1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E47FA0B-A204-A344-0101-29C8E8942F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7447CE6-ABAF-394C-AC5D-2CE5645C16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8BB6C45-EAFA-3BFE-BB56-7254251A3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6D05927-F31B-D908-34B2-ABD6DCEF8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5999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BD1886-71D0-44ED-3A5A-10D3597D7F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6B3829B-A48A-FF08-829A-4705FD1776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97E37E-61D4-69DE-4FA3-BFDE2547E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FEE283-E819-51E8-7FE5-B3E4B9D183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6B2A7E-1BA0-813D-80DA-038B148E0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882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BC37A49-C81B-4683-EC0F-C4B3B28CF8A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40DA49C-5E99-8FC5-AE42-178B434BF2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6D1FF96-B3F1-0112-AF1E-FA6CD0913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93CE852-FAE9-59BE-1311-FB4EBDED4E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33D9C9-2266-8259-02CE-D08AFD7C9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272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4444404-9DD3-5362-A794-D0F7EE17EB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B4A62DB-9C1A-87EA-1D16-AD1434F1049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321774-1D8E-B581-81EB-78A7D58325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CB40E7-4204-8C85-DFBD-CC08EF802C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1B49812-70ED-790A-4381-E5AA072E7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968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3C5AA0-BD07-6ADE-B10F-18D2C843C4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63A305F-583F-8080-484F-6DEF68DE3B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71B194B-813D-927B-2212-D494EC90C8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8E116E-9031-6AA4-44DC-1C216C071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960DFEC-7422-639B-E6E3-85FD37DC44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081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28F508-B77C-2626-C129-DF1DCCAB5D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B9FC9F9-7F73-4C2B-A6FD-13D2B39319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E493EEB-927D-7F64-3162-3904626A04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056FF0-63EE-958B-F962-3F131E1C0D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78FF4F0-CA9B-05A7-E580-A79FB2A682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E8FDAC-9E87-E128-46F5-916D73AC4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114181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5FAC46-688B-75C5-E3DC-E66921AFEA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45DBE4F-00ED-4957-6DA8-364A791D95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379423A-3177-20C5-BB68-A8738BC496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98BA77A-1F11-19A0-8889-2E5D6CF122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D1C2366-704F-8EBE-BA57-C911415CB1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904B23B-59B3-7BE9-CC26-2364B949D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F270C9E-FDC5-4F26-F289-2FF9C80C6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F19C0FA-56C7-C7E4-8BE6-4F6739126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7416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F3466AA-5564-1A52-FAD8-101AE90EA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35977A3-81A5-049D-ED5B-5EFB7D5BF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4B60553-954A-AF97-8E84-64673E1F33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09C6E68-A2EC-6FCB-F3E0-C2A6A86D0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9221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460BEFA-38C1-343B-2604-8ED7140D75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AA328F3-E045-509F-ABE7-2A8A5F7CE4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E663ABE-539E-F56B-F550-5507D18B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8747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686F81-5ED3-77AF-C783-242294BD0D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60CA0C-4522-BBB1-B8A9-9CBECDDFFA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FFD01C3-34CB-E012-F06C-07CA1CA565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AE6AB82-C19A-C500-42CB-F6FBD72BA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9810B74-5AF7-3D95-2B2E-9B93B52C59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BEC2DDB-6767-5D98-1258-3C56BBA852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1374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24D348-970C-40CC-8ACA-6D0F51343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1BC11EB-3A80-D1D0-7C9C-072FBC5EC4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C401F57-32F2-1B2E-959E-B01DDCB860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7848522-CEAD-6768-4B73-0A27F47FC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D89DC3E-D0EA-B2EC-E2AC-4B17AD886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7D5DE06-5D9E-94B8-17A1-9FC44D933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6786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B2F3E2C-8FB5-BCEE-BA65-9130E4A7E4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9953BD-90A6-8F85-DE67-A278189D8B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06CE81B-3641-8E61-9938-3EADF49F9C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604F6-8365-48D2-958C-40FE5FEFE0FF}" type="datetimeFigureOut">
              <a:rPr lang="zh-CN" altLang="en-US" smtClean="0"/>
              <a:t>2025/9/1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5626A8-48D9-126C-A643-187F86EC65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C6BFC04-2416-D01E-DC59-B9862D4417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E7774-EC87-4F72-B1AE-477EC7A4FC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2205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5D097478-E472-2D74-B2EB-B02440199E39}"/>
              </a:ext>
            </a:extLst>
          </p:cNvPr>
          <p:cNvSpPr txBox="1"/>
          <p:nvPr/>
        </p:nvSpPr>
        <p:spPr>
          <a:xfrm>
            <a:off x="2479565" y="1028817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A034D77-94CB-182F-86C1-B11D863637B8}"/>
              </a:ext>
            </a:extLst>
          </p:cNvPr>
          <p:cNvSpPr txBox="1"/>
          <p:nvPr/>
        </p:nvSpPr>
        <p:spPr>
          <a:xfrm>
            <a:off x="6501416" y="933214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BK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59BECCC8-9AF9-EC51-4B48-29C738DBE04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6456" t="25210" r="40605" b="24631"/>
          <a:stretch>
            <a:fillRect/>
          </a:stretch>
        </p:blipFill>
        <p:spPr>
          <a:xfrm>
            <a:off x="3580575" y="583410"/>
            <a:ext cx="1410619" cy="24748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4BDF238C-8DAF-DC1B-7EA0-8DBDE8A3690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0106" t="15398" r="35056" b="28758"/>
          <a:stretch>
            <a:fillRect/>
          </a:stretch>
        </p:blipFill>
        <p:spPr>
          <a:xfrm>
            <a:off x="7566852" y="583410"/>
            <a:ext cx="1371906" cy="2474877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F5E8A847-D709-D770-EE57-25CEF411ECAE}"/>
              </a:ext>
            </a:extLst>
          </p:cNvPr>
          <p:cNvSpPr/>
          <p:nvPr/>
        </p:nvSpPr>
        <p:spPr>
          <a:xfrm>
            <a:off x="3389090" y="1028817"/>
            <a:ext cx="185848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BA961602-0682-441B-AF0D-92088D5869F1}"/>
              </a:ext>
            </a:extLst>
          </p:cNvPr>
          <p:cNvSpPr/>
          <p:nvPr/>
        </p:nvSpPr>
        <p:spPr>
          <a:xfrm>
            <a:off x="7274509" y="912297"/>
            <a:ext cx="1858488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BB3FB20-4B2A-9483-C85D-ED2913E91A7A}"/>
              </a:ext>
            </a:extLst>
          </p:cNvPr>
          <p:cNvSpPr txBox="1"/>
          <p:nvPr/>
        </p:nvSpPr>
        <p:spPr>
          <a:xfrm>
            <a:off x="3425343" y="311718"/>
            <a:ext cx="160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CA6C70B-FBAA-34D2-0FC4-8AD576412C50}"/>
              </a:ext>
            </a:extLst>
          </p:cNvPr>
          <p:cNvSpPr txBox="1"/>
          <p:nvPr/>
        </p:nvSpPr>
        <p:spPr>
          <a:xfrm>
            <a:off x="2663570" y="311718"/>
            <a:ext cx="819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68163F1-C5ED-115E-EDC1-4422DF0F4EF8}"/>
              </a:ext>
            </a:extLst>
          </p:cNvPr>
          <p:cNvSpPr txBox="1"/>
          <p:nvPr/>
        </p:nvSpPr>
        <p:spPr>
          <a:xfrm>
            <a:off x="7336654" y="311717"/>
            <a:ext cx="160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A06CEB2B-576D-4212-88EA-78EA3D5A9551}"/>
              </a:ext>
            </a:extLst>
          </p:cNvPr>
          <p:cNvSpPr txBox="1"/>
          <p:nvPr/>
        </p:nvSpPr>
        <p:spPr>
          <a:xfrm>
            <a:off x="6574881" y="311717"/>
            <a:ext cx="819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8A8467E3-FA68-92F6-8CB5-42D04D954D1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38" t="29224" r="54286" b="25858"/>
          <a:stretch>
            <a:fillRect/>
          </a:stretch>
        </p:blipFill>
        <p:spPr>
          <a:xfrm flipH="1">
            <a:off x="3389090" y="3800332"/>
            <a:ext cx="1799964" cy="284772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DA08A5D1-9798-B5B2-66BB-9A905D13B0B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24" t="26786" r="50245" b="31461"/>
          <a:stretch>
            <a:fillRect/>
          </a:stretch>
        </p:blipFill>
        <p:spPr>
          <a:xfrm>
            <a:off x="7325204" y="3855958"/>
            <a:ext cx="1870605" cy="2897084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E6E63EBA-E94B-E0F9-88EE-30B631DB02CC}"/>
              </a:ext>
            </a:extLst>
          </p:cNvPr>
          <p:cNvSpPr/>
          <p:nvPr/>
        </p:nvSpPr>
        <p:spPr>
          <a:xfrm>
            <a:off x="3143572" y="4272991"/>
            <a:ext cx="2291168" cy="4555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9DAD1AE-4C15-831E-B4EC-D5E894A5F96C}"/>
              </a:ext>
            </a:extLst>
          </p:cNvPr>
          <p:cNvSpPr txBox="1"/>
          <p:nvPr/>
        </p:nvSpPr>
        <p:spPr>
          <a:xfrm>
            <a:off x="2096736" y="4316081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3CD6F14-76F5-D6B0-9A64-239C27045A58}"/>
              </a:ext>
            </a:extLst>
          </p:cNvPr>
          <p:cNvSpPr txBox="1"/>
          <p:nvPr/>
        </p:nvSpPr>
        <p:spPr>
          <a:xfrm>
            <a:off x="3424337" y="3467609"/>
            <a:ext cx="16256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6BE385B-836A-D8FC-A3A5-123AD54DD93A}"/>
              </a:ext>
            </a:extLst>
          </p:cNvPr>
          <p:cNvSpPr txBox="1"/>
          <p:nvPr/>
        </p:nvSpPr>
        <p:spPr>
          <a:xfrm>
            <a:off x="2615770" y="3467609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6B17F35A-9F9F-843C-5B79-6A4FFF54F8B7}"/>
              </a:ext>
            </a:extLst>
          </p:cNvPr>
          <p:cNvSpPr/>
          <p:nvPr/>
        </p:nvSpPr>
        <p:spPr>
          <a:xfrm>
            <a:off x="7132459" y="4842825"/>
            <a:ext cx="229116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6FCA2C5E-AAE6-BBD4-80ED-3394E020A3D1}"/>
              </a:ext>
            </a:extLst>
          </p:cNvPr>
          <p:cNvSpPr txBox="1"/>
          <p:nvPr/>
        </p:nvSpPr>
        <p:spPr>
          <a:xfrm>
            <a:off x="6190390" y="4854861"/>
            <a:ext cx="10687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RF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5F371986-85F4-7C74-AD87-20220EAC31F8}"/>
              </a:ext>
            </a:extLst>
          </p:cNvPr>
          <p:cNvSpPr txBox="1"/>
          <p:nvPr/>
        </p:nvSpPr>
        <p:spPr>
          <a:xfrm>
            <a:off x="7362505" y="3518165"/>
            <a:ext cx="20611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   75   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F843E74F-74E5-D0F0-C0E2-9EA6903A84E0}"/>
              </a:ext>
            </a:extLst>
          </p:cNvPr>
          <p:cNvSpPr txBox="1"/>
          <p:nvPr/>
        </p:nvSpPr>
        <p:spPr>
          <a:xfrm>
            <a:off x="6503143" y="3518165"/>
            <a:ext cx="8593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17255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5CEF8251-214C-B6A4-4556-EEC0CA6DEED3}"/>
              </a:ext>
            </a:extLst>
          </p:cNvPr>
          <p:cNvSpPr txBox="1"/>
          <p:nvPr/>
        </p:nvSpPr>
        <p:spPr>
          <a:xfrm>
            <a:off x="2161936" y="1768374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Viper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88A9200-5200-525B-42F3-91F1FE60A3CA}"/>
              </a:ext>
            </a:extLst>
          </p:cNvPr>
          <p:cNvSpPr txBox="1"/>
          <p:nvPr/>
        </p:nvSpPr>
        <p:spPr>
          <a:xfrm>
            <a:off x="6360681" y="1185304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FIT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DB0A08AA-6AEA-F466-8BBA-0B1A5310152A}"/>
              </a:ext>
            </a:extLst>
          </p:cNvPr>
          <p:cNvSpPr txBox="1"/>
          <p:nvPr/>
        </p:nvSpPr>
        <p:spPr>
          <a:xfrm>
            <a:off x="2476199" y="4547455"/>
            <a:ext cx="10173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OA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978B44DD-EAEF-6A25-2A59-24283AEB437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31908" t="19219" r="44057" b="30133"/>
          <a:stretch>
            <a:fillRect/>
          </a:stretch>
        </p:blipFill>
        <p:spPr>
          <a:xfrm>
            <a:off x="3373521" y="530936"/>
            <a:ext cx="1463773" cy="2474877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8F7FD4D-A028-B4C1-FA46-969912294BB0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8257" t="14145" r="39259" b="29400"/>
          <a:stretch>
            <a:fillRect/>
          </a:stretch>
        </p:blipFill>
        <p:spPr>
          <a:xfrm>
            <a:off x="7354708" y="519511"/>
            <a:ext cx="1228536" cy="2474877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F2AA918-BE3A-D050-4600-0846A913FBEC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5432" t="19092" r="50570" b="21331"/>
          <a:stretch>
            <a:fillRect/>
          </a:stretch>
        </p:blipFill>
        <p:spPr>
          <a:xfrm>
            <a:off x="3493545" y="3852188"/>
            <a:ext cx="1242477" cy="2474877"/>
          </a:xfrm>
          <a:custGeom>
            <a:avLst/>
            <a:gdLst>
              <a:gd name="connsiteX0" fmla="*/ 0 w 1889357"/>
              <a:gd name="connsiteY0" fmla="*/ 0 h 398665"/>
              <a:gd name="connsiteX1" fmla="*/ 1889357 w 1889357"/>
              <a:gd name="connsiteY1" fmla="*/ 0 h 398665"/>
              <a:gd name="connsiteX2" fmla="*/ 1889357 w 1889357"/>
              <a:gd name="connsiteY2" fmla="*/ 398665 h 398665"/>
              <a:gd name="connsiteX3" fmla="*/ 0 w 1889357"/>
              <a:gd name="connsiteY3" fmla="*/ 398665 h 3986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889357" h="398665">
                <a:moveTo>
                  <a:pt x="0" y="0"/>
                </a:moveTo>
                <a:lnTo>
                  <a:pt x="1889357" y="0"/>
                </a:lnTo>
                <a:lnTo>
                  <a:pt x="1889357" y="398665"/>
                </a:lnTo>
                <a:lnTo>
                  <a:pt x="0" y="398665"/>
                </a:lnTo>
                <a:close/>
              </a:path>
            </a:pathLst>
          </a:custGeom>
          <a:ln w="12700">
            <a:solidFill>
              <a:schemeClr val="tx1"/>
            </a:solidFill>
          </a:ln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BE38C81C-9228-5870-220D-ADDC8C86861D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37383" t="23460" r="40562" b="26579"/>
          <a:stretch>
            <a:fillRect/>
          </a:stretch>
        </p:blipFill>
        <p:spPr>
          <a:xfrm>
            <a:off x="7354708" y="3863614"/>
            <a:ext cx="1371906" cy="24937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2B139068-C600-1CC9-338D-9CA55B9E707F}"/>
              </a:ext>
            </a:extLst>
          </p:cNvPr>
          <p:cNvSpPr txBox="1"/>
          <p:nvPr/>
        </p:nvSpPr>
        <p:spPr>
          <a:xfrm>
            <a:off x="5917687" y="5063622"/>
            <a:ext cx="13763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eta Act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79D65B8A-BE3C-37BE-E0CF-0049E8EB29A0}"/>
              </a:ext>
            </a:extLst>
          </p:cNvPr>
          <p:cNvSpPr/>
          <p:nvPr/>
        </p:nvSpPr>
        <p:spPr>
          <a:xfrm>
            <a:off x="3179282" y="1781716"/>
            <a:ext cx="185848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DACACD3D-1C8D-B0C2-5259-DFEC89AB069D}"/>
              </a:ext>
            </a:extLst>
          </p:cNvPr>
          <p:cNvSpPr/>
          <p:nvPr/>
        </p:nvSpPr>
        <p:spPr>
          <a:xfrm>
            <a:off x="7108435" y="1185304"/>
            <a:ext cx="185848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B25D7E6E-95A9-3342-0BA7-7FB04C748CCB}"/>
              </a:ext>
            </a:extLst>
          </p:cNvPr>
          <p:cNvSpPr/>
          <p:nvPr/>
        </p:nvSpPr>
        <p:spPr>
          <a:xfrm>
            <a:off x="3256919" y="4522141"/>
            <a:ext cx="185848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843D6610-75FB-EB60-850C-D9615516480A}"/>
              </a:ext>
            </a:extLst>
          </p:cNvPr>
          <p:cNvSpPr/>
          <p:nvPr/>
        </p:nvSpPr>
        <p:spPr>
          <a:xfrm>
            <a:off x="7170232" y="5063622"/>
            <a:ext cx="1858488" cy="369332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DEF1605-501F-B6FB-3DAB-7D721C8B4BA8}"/>
              </a:ext>
            </a:extLst>
          </p:cNvPr>
          <p:cNvSpPr txBox="1"/>
          <p:nvPr/>
        </p:nvSpPr>
        <p:spPr>
          <a:xfrm>
            <a:off x="3343057" y="223159"/>
            <a:ext cx="160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D3811D6-D9CD-B292-F2C9-976759A3F687}"/>
              </a:ext>
            </a:extLst>
          </p:cNvPr>
          <p:cNvSpPr txBox="1"/>
          <p:nvPr/>
        </p:nvSpPr>
        <p:spPr>
          <a:xfrm>
            <a:off x="2581284" y="223159"/>
            <a:ext cx="819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BDD420F3-7B12-89EC-B79E-7B56E4C74F85}"/>
              </a:ext>
            </a:extLst>
          </p:cNvPr>
          <p:cNvSpPr txBox="1"/>
          <p:nvPr/>
        </p:nvSpPr>
        <p:spPr>
          <a:xfrm>
            <a:off x="7108435" y="223159"/>
            <a:ext cx="160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6FEF827-2B81-1E3B-D2FF-9295DCAB1CC6}"/>
              </a:ext>
            </a:extLst>
          </p:cNvPr>
          <p:cNvSpPr txBox="1"/>
          <p:nvPr/>
        </p:nvSpPr>
        <p:spPr>
          <a:xfrm>
            <a:off x="6346662" y="223159"/>
            <a:ext cx="819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A21CDEE-B128-2C49-1F09-E7D293533AF4}"/>
              </a:ext>
            </a:extLst>
          </p:cNvPr>
          <p:cNvSpPr txBox="1"/>
          <p:nvPr/>
        </p:nvSpPr>
        <p:spPr>
          <a:xfrm>
            <a:off x="3256919" y="3555837"/>
            <a:ext cx="160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438B5A10-96DC-BF56-B159-CA7B8258CAF3}"/>
              </a:ext>
            </a:extLst>
          </p:cNvPr>
          <p:cNvSpPr txBox="1"/>
          <p:nvPr/>
        </p:nvSpPr>
        <p:spPr>
          <a:xfrm>
            <a:off x="2495146" y="3555837"/>
            <a:ext cx="819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CBDFE05-EB1E-53F1-7613-D19B913CE879}"/>
              </a:ext>
            </a:extLst>
          </p:cNvPr>
          <p:cNvSpPr txBox="1"/>
          <p:nvPr/>
        </p:nvSpPr>
        <p:spPr>
          <a:xfrm>
            <a:off x="7170232" y="3555837"/>
            <a:ext cx="1602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MSO 50 75 100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5F5B1C6-A472-7737-E529-53F2EBFDAE5E}"/>
              </a:ext>
            </a:extLst>
          </p:cNvPr>
          <p:cNvSpPr txBox="1"/>
          <p:nvPr/>
        </p:nvSpPr>
        <p:spPr>
          <a:xfrm>
            <a:off x="6408459" y="3555837"/>
            <a:ext cx="8198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BT (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4902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73</Words>
  <Application>Microsoft Office PowerPoint</Application>
  <PresentationFormat>宽屏</PresentationFormat>
  <Paragraphs>24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星宇 陈</dc:creator>
  <cp:lastModifiedBy>星宇 陈</cp:lastModifiedBy>
  <cp:revision>5</cp:revision>
  <dcterms:created xsi:type="dcterms:W3CDTF">2025-08-14T12:29:27Z</dcterms:created>
  <dcterms:modified xsi:type="dcterms:W3CDTF">2025-09-11T10:28:17Z</dcterms:modified>
</cp:coreProperties>
</file>